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27432000" cy="27432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9A6A79-4D94-43D0-A825-85B3D6A0DE1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371600" y="1098720"/>
            <a:ext cx="24688800" cy="457200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ctr">
            <a:noAutofit/>
          </a:bodyPr>
          <a:p>
            <a:pPr indent="0" algn="ctr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1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371600" y="6400440"/>
            <a:ext cx="2468880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1371600" y="15857280"/>
            <a:ext cx="2468880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C0132B-3D94-472B-9D36-66DF7FEA91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371600" y="1098720"/>
            <a:ext cx="24688800" cy="457200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ctr">
            <a:noAutofit/>
          </a:bodyPr>
          <a:p>
            <a:pPr indent="0" algn="ctr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1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371600" y="6400440"/>
            <a:ext cx="1204812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14022360" y="6400440"/>
            <a:ext cx="1204812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371600" y="15857280"/>
            <a:ext cx="1204812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14022360" y="15857280"/>
            <a:ext cx="1204812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6F466F-A9A7-4B12-B29B-29120AB12A4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371600" y="1098720"/>
            <a:ext cx="24688800" cy="457200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ctr">
            <a:noAutofit/>
          </a:bodyPr>
          <a:p>
            <a:pPr indent="0" algn="ctr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1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371600" y="6400440"/>
            <a:ext cx="794952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9718920" y="6400440"/>
            <a:ext cx="794952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18066240" y="6400440"/>
            <a:ext cx="794952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1371600" y="15857280"/>
            <a:ext cx="794952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9718920" y="15857280"/>
            <a:ext cx="794952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18066240" y="15857280"/>
            <a:ext cx="794952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388F63-92D2-4BA5-997C-7364C238C9B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371600" y="1098720"/>
            <a:ext cx="24688800" cy="457200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ctr">
            <a:noAutofit/>
          </a:bodyPr>
          <a:p>
            <a:pPr indent="0" algn="ctr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1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1371600" y="6400440"/>
            <a:ext cx="24688800" cy="18105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276"/>
              </a:spcBef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50CBB1-389A-486A-923D-D44CCAB286F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371600" y="1098720"/>
            <a:ext cx="24688800" cy="457200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ctr">
            <a:noAutofit/>
          </a:bodyPr>
          <a:p>
            <a:pPr indent="0" algn="ctr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1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1371600" y="6400440"/>
            <a:ext cx="24688800" cy="1810548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641D95-36C8-4A5B-993B-1C526D3567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371600" y="1098720"/>
            <a:ext cx="24688800" cy="457200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ctr">
            <a:noAutofit/>
          </a:bodyPr>
          <a:p>
            <a:pPr indent="0" algn="ctr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1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1371600" y="6400440"/>
            <a:ext cx="12048120" cy="1810548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14022360" y="6400440"/>
            <a:ext cx="12048120" cy="1810548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A16EDC-B4A5-43CD-BA44-CC78027981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371600" y="1098720"/>
            <a:ext cx="24688800" cy="457200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ctr">
            <a:noAutofit/>
          </a:bodyPr>
          <a:p>
            <a:pPr indent="0" algn="ctr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1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D4D6CC-214B-4DD8-A2E7-BF4ECB17A5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371600" y="1098720"/>
            <a:ext cx="24688800" cy="2119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276"/>
              </a:spcBef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81D6DE-E22C-4A18-80A8-6F9E101A3B7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371600" y="1098720"/>
            <a:ext cx="24688800" cy="457200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ctr">
            <a:noAutofit/>
          </a:bodyPr>
          <a:p>
            <a:pPr indent="0" algn="ctr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1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371600" y="6400440"/>
            <a:ext cx="1204812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14022360" y="6400440"/>
            <a:ext cx="12048120" cy="1810548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1371600" y="15857280"/>
            <a:ext cx="1204812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78E273-FFBD-440E-B84E-316F486053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371600" y="1098720"/>
            <a:ext cx="24688800" cy="457200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ctr">
            <a:noAutofit/>
          </a:bodyPr>
          <a:p>
            <a:pPr indent="0" algn="ctr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1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1371600" y="6400440"/>
            <a:ext cx="12048120" cy="1810548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14022360" y="6400440"/>
            <a:ext cx="1204812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14022360" y="15857280"/>
            <a:ext cx="1204812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9564BD-AC7D-4ECD-80A9-8B95108632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371600" y="1098720"/>
            <a:ext cx="24688800" cy="457200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ctr">
            <a:noAutofit/>
          </a:bodyPr>
          <a:p>
            <a:pPr indent="0" algn="ctr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1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371600" y="6400440"/>
            <a:ext cx="1204812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14022360" y="6400440"/>
            <a:ext cx="1204812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1371600" y="15857280"/>
            <a:ext cx="2468880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8F6C56-65C4-4F8F-8E68-91A66AC7E6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371600" y="1098720"/>
            <a:ext cx="24688800" cy="457200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ctr">
            <a:noAutofit/>
          </a:bodyPr>
          <a:p>
            <a:pPr indent="0" algn="ctr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0" lang="en-US" sz="126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1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1371600" y="6400440"/>
            <a:ext cx="24688800" cy="1810548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marL="979560" indent="-979560">
              <a:spcBef>
                <a:spcPts val="2276"/>
              </a:spcBef>
              <a:buClr>
                <a:srgbClr val="000000"/>
              </a:buClr>
              <a:buFont typeface="Arial"/>
              <a:buChar char="•"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0" lang="en-US" sz="9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  <a:p>
            <a:pPr lvl="1" marL="2122560" indent="-816120">
              <a:spcBef>
                <a:spcPts val="2276"/>
              </a:spcBef>
              <a:buClr>
                <a:srgbClr val="000000"/>
              </a:buClr>
              <a:buFont typeface="Arial"/>
              <a:buChar char="–"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0" lang="en-US" sz="9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  <a:p>
            <a:pPr lvl="2" marL="3265560" indent="-652680">
              <a:spcBef>
                <a:spcPts val="2276"/>
              </a:spcBef>
              <a:buClr>
                <a:srgbClr val="000000"/>
              </a:buClr>
              <a:buFont typeface="Arial"/>
              <a:buChar char="•"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0" lang="en-US" sz="9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  <a:p>
            <a:pPr lvl="3" marL="4572000" indent="-654120">
              <a:spcBef>
                <a:spcPts val="2276"/>
              </a:spcBef>
              <a:buClr>
                <a:srgbClr val="000000"/>
              </a:buClr>
              <a:buFont typeface="Arial"/>
              <a:buChar char="–"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0" lang="en-US" sz="9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  <a:p>
            <a:pPr lvl="4" marL="5878440" indent="-654120">
              <a:spcBef>
                <a:spcPts val="2276"/>
              </a:spcBef>
              <a:buClr>
                <a:srgbClr val="000000"/>
              </a:buClr>
              <a:buFont typeface="Arial"/>
              <a:buChar char="»"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0" lang="en-US" sz="9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  <a:p>
            <a:pPr lvl="5" marL="5878440" indent="-654120">
              <a:spcBef>
                <a:spcPts val="2276"/>
              </a:spcBef>
              <a:buClr>
                <a:srgbClr val="000000"/>
              </a:buClr>
              <a:buFont typeface="Arial"/>
              <a:buChar char="»"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0" lang="en-US" sz="9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  <a:p>
            <a:pPr lvl="6" marL="5878440" indent="-654120">
              <a:spcBef>
                <a:spcPts val="2276"/>
              </a:spcBef>
              <a:buClr>
                <a:srgbClr val="000000"/>
              </a:buClr>
              <a:buFont typeface="Arial"/>
              <a:buChar char="»"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0" lang="en-US" sz="9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1371600" y="24982200"/>
            <a:ext cx="6400800" cy="190476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Autofit/>
          </a:bodyPr>
          <a:lstStyle>
            <a:lvl1pPr indent="0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  <a:defRPr b="0" lang="en-US" sz="4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9372600" y="24982200"/>
            <a:ext cx="8686800" cy="190476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Autofit/>
          </a:bodyPr>
          <a:lstStyle>
            <a:lvl1pPr indent="0" algn="ctr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  <a:defRPr b="0" lang="en-US" sz="4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19659600" y="24982200"/>
            <a:ext cx="6400800" cy="190476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Autofit/>
          </a:bodyPr>
          <a:lstStyle>
            <a:lvl1pPr indent="0" algn="r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  <a:defRPr b="0" lang="en-US" sz="4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fld id="{0D16BE59-1F42-4E2C-8AB5-E422ADE21BB6}" type="slidenum">
              <a:rPr b="0" lang="en-US" sz="4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27432000" cy="24640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61360" rIns="261360" tIns="130680" bIns="1306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Courier New"/>
              </a:rPr>
              <a:t>                                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10                            20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VL   agtattgtgatgacccagactcccaaattcctgcttgtatcagcaggagacagggttaccataacctgcaaggccagt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   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S  I  V  M  T  Q  T  P  K  F  L  L  V  S  A  G  D  R  V  T  I  T  C  K  A  S 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1F9  agtattgtgatgacccagactcccaaattcctgc</a:t>
            </a:r>
            <a:r>
              <a:rPr b="1" lang="en-US" sz="4000" spc="-1" strike="noStrike">
                <a:solidFill>
                  <a:srgbClr val="ff0066"/>
                </a:solidFill>
                <a:latin typeface="Courier New"/>
              </a:rPr>
              <a:t>c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tgtatcagcaggagacagggttaccataa</a:t>
            </a:r>
            <a:r>
              <a:rPr b="1" lang="en-US" sz="4000" spc="-1" strike="noStrike">
                <a:solidFill>
                  <a:srgbClr val="ff0066"/>
                </a:solidFill>
                <a:latin typeface="Courier New"/>
              </a:rPr>
              <a:t>t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ctg</a:t>
            </a:r>
            <a:r>
              <a:rPr b="1" lang="en-US" sz="4000" spc="-1" strike="noStrike">
                <a:solidFill>
                  <a:srgbClr val="ff0066"/>
                </a:solidFill>
                <a:latin typeface="Courier New"/>
              </a:rPr>
              <a:t>t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aaggccagt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   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S  I  V  M  T  Q  T  P  K  F  L  </a:t>
            </a:r>
            <a:r>
              <a:rPr b="1" lang="en-US" sz="4000" spc="-1" strike="noStrike">
                <a:solidFill>
                  <a:srgbClr val="ff0066"/>
                </a:solidFill>
                <a:latin typeface="Courier New"/>
              </a:rPr>
              <a:t>P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V  S  A  G  D  R  V  T  I  </a:t>
            </a:r>
            <a:r>
              <a:rPr b="1" lang="en-US" sz="4000" spc="-1" strike="noStrike">
                <a:solidFill>
                  <a:srgbClr val="ff0066"/>
                </a:solidFill>
                <a:latin typeface="Courier New"/>
              </a:rPr>
              <a:t>I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C  </a:t>
            </a:r>
            <a:r>
              <a:rPr b="1" lang="en-US" sz="4000" spc="-1" strike="noStrike" u="sng">
                <a:solidFill>
                  <a:srgbClr val="000000"/>
                </a:solidFill>
                <a:uFillTx/>
                <a:latin typeface="Courier New"/>
              </a:rPr>
              <a:t>K  A  S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           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30                            40                            50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VL   cagagtgtgagtaatgatgtagcttggtaccaacagaagccagggcagtctcctaaactgctgatatactatgcatcc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   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Q  S  V  S  N  D  V  A  W  Y  Q  Q  K  P  G  Q  S  P  K  L  L  I  Y  Y  A  S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1F9  cagagtgtgagtaatgatgtag</a:t>
            </a:r>
            <a:r>
              <a:rPr b="1" lang="en-US" sz="4000" spc="-1" strike="noStrike">
                <a:solidFill>
                  <a:srgbClr val="ff0066"/>
                </a:solidFill>
                <a:latin typeface="Courier New"/>
              </a:rPr>
              <a:t>t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ttggtaccaacagaagccagggcagtctcctaaactgctgatatactatgc</a:t>
            </a:r>
            <a:r>
              <a:rPr b="1" lang="en-US" sz="4000" spc="-1" strike="noStrike" u="sng">
                <a:solidFill>
                  <a:srgbClr val="000000"/>
                </a:solidFill>
                <a:uFillTx/>
                <a:latin typeface="Courier New"/>
              </a:rPr>
              <a:t>g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tcc 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   </a:t>
            </a:r>
            <a:r>
              <a:rPr b="1" lang="en-US" sz="4000" spc="-1" strike="noStrike" u="sng">
                <a:solidFill>
                  <a:srgbClr val="000000"/>
                </a:solidFill>
                <a:uFillTx/>
                <a:latin typeface="Courier New"/>
              </a:rPr>
              <a:t>Q  S  V  S  N  D  V  </a:t>
            </a:r>
            <a:r>
              <a:rPr b="1" lang="en-US" sz="4000" spc="-1" strike="noStrike" u="sng">
                <a:solidFill>
                  <a:srgbClr val="ff0066"/>
                </a:solidFill>
                <a:uFillTx/>
                <a:latin typeface="Courier New"/>
              </a:rPr>
              <a:t>V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W  Y  Q  Q  K  P  G  Q  S  P  K  L  L  I  Y  </a:t>
            </a:r>
            <a:r>
              <a:rPr b="1" lang="en-US" sz="4000" spc="-1" strike="noStrike" u="sng">
                <a:solidFill>
                  <a:srgbClr val="000000"/>
                </a:solidFill>
                <a:uFillTx/>
                <a:latin typeface="Courier New"/>
              </a:rPr>
              <a:t>Y  A  S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      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CDR1       </a:t>
            </a:r>
            <a:r>
              <a:rPr b="1" lang="en-US" sz="4000" spc="-1" strike="noStrike" u="sng">
                <a:solidFill>
                  <a:srgbClr val="33cc33"/>
                </a:solidFill>
                <a:uFillTx/>
                <a:latin typeface="Courier New"/>
              </a:rPr>
              <a:t>24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1" lang="en-US" sz="4000" spc="-1" strike="noStrike">
                <a:solidFill>
                  <a:srgbClr val="33cc33"/>
                </a:solidFill>
                <a:latin typeface="Courier New"/>
              </a:rPr>
              <a:t>14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                                           </a:t>
            </a:r>
            <a:r>
              <a:rPr b="1" lang="en-US" sz="4000" spc="-1" strike="noStrike">
                <a:solidFill>
                  <a:srgbClr val="33cc33"/>
                </a:solidFill>
                <a:latin typeface="Courier New"/>
              </a:rPr>
              <a:t>66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1" lang="en-US" sz="4000" spc="-1" strike="noStrike">
                <a:solidFill>
                  <a:srgbClr val="33cc33"/>
                </a:solidFill>
                <a:latin typeface="Courier New"/>
              </a:rPr>
              <a:t>72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CDR2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                       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60                            70                         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VL   aatcgctacactggagtccctgatcgcttcactggcagtggatatgggacggatttcactttcaccatcagcactgtg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   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N  R  Y  T  G  V  P  D  R  F  T  G  S  G  Y  G  T  D  F  T  F  T  I  S  T  V  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1F9  a</a:t>
            </a:r>
            <a:r>
              <a:rPr b="1" lang="en-US" sz="4000" spc="-1" strike="noStrike">
                <a:solidFill>
                  <a:srgbClr val="ff0066"/>
                </a:solidFill>
                <a:latin typeface="Courier New"/>
              </a:rPr>
              <a:t>t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tcgctacactggagtccctgatcgcttcactggcagtggatatgggacggatttcactttcaccatcagcactgtg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   </a:t>
            </a:r>
            <a:r>
              <a:rPr b="1" lang="en-US" sz="4000" spc="-1" strike="noStrike" u="sng">
                <a:solidFill>
                  <a:srgbClr val="ff0066"/>
                </a:solidFill>
                <a:uFillTx/>
                <a:latin typeface="Courier New"/>
              </a:rPr>
              <a:t>I</a:t>
            </a:r>
            <a:r>
              <a:rPr b="1" lang="en-US" sz="4000" spc="-1" strike="noStrike" u="sng">
                <a:solidFill>
                  <a:srgbClr val="000000"/>
                </a:solidFill>
                <a:uFillTx/>
                <a:latin typeface="Courier New"/>
              </a:rPr>
              <a:t>  R  Y  T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G  V  P  D  R  F  T  G  S  G  Y  G  T  D  F  T  F  T  I  S  T  V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  </a:t>
            </a:r>
            <a:r>
              <a:rPr b="1" lang="en-US" sz="4000" spc="-1" strike="noStrike">
                <a:solidFill>
                  <a:srgbClr val="33cc33"/>
                </a:solidFill>
                <a:latin typeface="Courier New"/>
              </a:rPr>
              <a:t>24    42 </a:t>
            </a:r>
            <a:r>
              <a:rPr b="1" lang="en-US" sz="4000" spc="-1" strike="noStrike" u="sng">
                <a:solidFill>
                  <a:srgbClr val="33cc33"/>
                </a:solidFill>
                <a:uFillTx/>
                <a:latin typeface="Courier New"/>
              </a:rPr>
              <a:t>72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   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     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80                            90                           100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VL   caggctgaagacctggcagtttatttctgtcagcaggattatagctctcctc</a:t>
            </a:r>
            <a:r>
              <a:rPr b="1" lang="en-US" sz="4000" spc="-1" strike="noStrike">
                <a:solidFill>
                  <a:srgbClr val="0000ff"/>
                </a:solidFill>
                <a:latin typeface="Courier New"/>
              </a:rPr>
              <a:t>cCACAGTGcttcagcctcctACACAAACC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   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Q  A  E  D  L  A  V  Y  F  C  Q  Q  D  Y  S  S  P    </a:t>
            </a:r>
            <a:r>
              <a:rPr b="1" lang="en-US" sz="4000" spc="-1" strike="noStrike">
                <a:solidFill>
                  <a:srgbClr val="0000ff"/>
                </a:solidFill>
                <a:latin typeface="Courier New"/>
              </a:rPr>
              <a:t>7 mer              9 mer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J2              </a:t>
            </a:r>
            <a:r>
              <a:rPr b="1" lang="en-US" sz="4000" spc="-1" strike="noStrike">
                <a:solidFill>
                  <a:srgbClr val="0000ff"/>
                </a:solidFill>
                <a:latin typeface="Courier New"/>
              </a:rPr>
              <a:t>GGTTTTTGTacagccagacagtggagtactacCACTGTGgt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ggacgttcggtggaggcaccaagctg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                  </a:t>
            </a:r>
            <a:r>
              <a:rPr b="1" lang="pt-BR" sz="4000" spc="-1" strike="noStrike">
                <a:solidFill>
                  <a:srgbClr val="0000ff"/>
                </a:solidFill>
                <a:latin typeface="Courier New"/>
              </a:rPr>
              <a:t>9 mer                          7 mer</a:t>
            </a: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      T  F  G  G  G  T  K  L 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1F9  cagg</a:t>
            </a:r>
            <a:r>
              <a:rPr b="1" lang="en-US" sz="4000" spc="-1" strike="noStrike">
                <a:solidFill>
                  <a:srgbClr val="ff0066"/>
                </a:solidFill>
                <a:latin typeface="Courier New"/>
              </a:rPr>
              <a:t>t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tgaagacctggcagtttatttctgtcagcagg</a:t>
            </a:r>
            <a:r>
              <a:rPr b="1" lang="en-US" sz="4000" spc="-1" strike="noStrike">
                <a:solidFill>
                  <a:srgbClr val="ff0066"/>
                </a:solidFill>
                <a:latin typeface="Courier New"/>
              </a:rPr>
              <a:t>g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tt</a:t>
            </a:r>
            <a:r>
              <a:rPr b="1" lang="en-US" sz="4000" spc="-1" strike="noStrike">
                <a:solidFill>
                  <a:srgbClr val="ff0066"/>
                </a:solidFill>
                <a:latin typeface="Courier New"/>
              </a:rPr>
              <a:t>t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tagctctcctcggacgttcggtggaggcaccaagctg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   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Q  </a:t>
            </a:r>
            <a:r>
              <a:rPr b="1" lang="en-US" sz="4000" spc="-1" strike="noStrike">
                <a:solidFill>
                  <a:srgbClr val="ff0066"/>
                </a:solidFill>
                <a:latin typeface="Courier New"/>
              </a:rPr>
              <a:t>V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E  D  L  A  V  Y  F  C  </a:t>
            </a:r>
            <a:r>
              <a:rPr b="1" lang="en-US" sz="4000" spc="-1" strike="noStrike" u="sng">
                <a:solidFill>
                  <a:srgbClr val="000000"/>
                </a:solidFill>
                <a:uFillTx/>
                <a:latin typeface="Courier New"/>
              </a:rPr>
              <a:t>Q  Q  </a:t>
            </a:r>
            <a:r>
              <a:rPr b="1" lang="en-US" sz="4000" spc="-1" strike="noStrike" u="sng">
                <a:solidFill>
                  <a:srgbClr val="ff0066"/>
                </a:solidFill>
                <a:uFillTx/>
                <a:latin typeface="Courier New"/>
              </a:rPr>
              <a:t>G</a:t>
            </a:r>
            <a:r>
              <a:rPr b="1" lang="en-US" sz="4000" spc="-1" strike="noStrike" u="sng">
                <a:solidFill>
                  <a:srgbClr val="000000"/>
                </a:solidFill>
                <a:uFillTx/>
                <a:latin typeface="Courier New"/>
              </a:rPr>
              <a:t>  </a:t>
            </a:r>
            <a:r>
              <a:rPr b="1" lang="en-US" sz="4000" spc="-1" strike="noStrike" u="sng">
                <a:solidFill>
                  <a:srgbClr val="ff0066"/>
                </a:solidFill>
                <a:uFillTx/>
                <a:latin typeface="Courier New"/>
              </a:rPr>
              <a:t>F</a:t>
            </a:r>
            <a:r>
              <a:rPr b="1" lang="en-US" sz="4000" spc="-1" strike="noStrike" u="sng">
                <a:solidFill>
                  <a:srgbClr val="000000"/>
                </a:solidFill>
                <a:uFillTx/>
                <a:latin typeface="Courier New"/>
              </a:rPr>
              <a:t>  S  S  P  </a:t>
            </a:r>
            <a:r>
              <a:rPr b="1" lang="pt-BR" sz="4000" spc="-1" strike="noStrike" u="sng">
                <a:solidFill>
                  <a:srgbClr val="000000"/>
                </a:solidFill>
                <a:uFillTx/>
                <a:latin typeface="Courier New"/>
              </a:rPr>
              <a:t>R  T</a:t>
            </a: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  F  G  G  G  T  K  L  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                                       </a:t>
            </a:r>
            <a:r>
              <a:rPr b="1" lang="en-US" sz="4000" spc="-1" strike="noStrike">
                <a:solidFill>
                  <a:srgbClr val="33cc33"/>
                </a:solidFill>
                <a:latin typeface="Courier New"/>
              </a:rPr>
              <a:t> 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CDR3      </a:t>
            </a:r>
            <a:r>
              <a:rPr b="1" lang="en-US" sz="4000" spc="-1" strike="noStrike" u="sng">
                <a:solidFill>
                  <a:srgbClr val="33cc33"/>
                </a:solidFill>
                <a:uFillTx/>
                <a:latin typeface="Courier New"/>
              </a:rPr>
              <a:t>37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                                 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                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110                           120                           130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J2   gaaatcaaAC</a:t>
            </a:r>
            <a:r>
              <a:rPr b="1" lang="en-US" sz="4000" spc="-1" strike="noStrike">
                <a:solidFill>
                  <a:srgbClr val="0000ff"/>
                </a:solidFill>
                <a:latin typeface="Courier New"/>
              </a:rPr>
              <a:t>GTAAGTagaatcc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      </a:t>
            </a: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E  I  K |</a:t>
            </a:r>
            <a:r>
              <a:rPr b="1" lang="pt-BR" sz="4000" spc="-1" strike="noStrike">
                <a:solidFill>
                  <a:srgbClr val="0000ff"/>
                </a:solidFill>
                <a:latin typeface="Courier New"/>
              </a:rPr>
              <a:t>splice donor</a:t>
            </a: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CL   </a:t>
            </a:r>
            <a:r>
              <a:rPr b="1" lang="en-US" sz="4000" spc="-1" strike="noStrike">
                <a:solidFill>
                  <a:srgbClr val="0000ff"/>
                </a:solidFill>
                <a:latin typeface="Courier New"/>
              </a:rPr>
              <a:t>CCTTCCTCAG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Gggctgatgctgcaccaactgtatccatcttcccaccatccagtgagcagttaacatctggaggtgcc 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  </a:t>
            </a:r>
            <a:r>
              <a:rPr b="1" lang="pt-BR" sz="4000" spc="-1" strike="noStrike">
                <a:solidFill>
                  <a:srgbClr val="0000ff"/>
                </a:solidFill>
                <a:latin typeface="Courier New"/>
              </a:rPr>
              <a:t>splice accept</a:t>
            </a: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|  </a:t>
            </a:r>
            <a:r>
              <a:rPr b="1" lang="en-AU" sz="4000" spc="-1" strike="noStrike">
                <a:solidFill>
                  <a:srgbClr val="000000"/>
                </a:solidFill>
                <a:latin typeface="Courier New"/>
              </a:rPr>
              <a:t>A  D  A  A  P  T  V  S  I  F  P  P  S  S  E  </a:t>
            </a: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Q  L  T  S  G  G  A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1F9  gaaatcaa</a:t>
            </a:r>
            <a:r>
              <a:rPr b="1" lang="en-US" sz="4000" spc="-1" strike="noStrike">
                <a:solidFill>
                  <a:srgbClr val="ff0066"/>
                </a:solidFill>
                <a:latin typeface="Courier New"/>
              </a:rPr>
              <a:t>t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cgggctgatgctgcaccaactgtat</a:t>
            </a:r>
            <a:r>
              <a:rPr b="1" i="1" lang="en-US" sz="4000" spc="-1" strike="noStrike">
                <a:solidFill>
                  <a:srgbClr val="000000"/>
                </a:solidFill>
                <a:latin typeface="Courier New"/>
              </a:rPr>
              <a:t>ccatcttcccaccatccagtgagcagttaacatctggaggtgcc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      </a:t>
            </a: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E  I  </a:t>
            </a:r>
            <a:r>
              <a:rPr b="1" lang="pt-BR" sz="4000" spc="-1" strike="noStrike">
                <a:solidFill>
                  <a:srgbClr val="ff0066"/>
                </a:solidFill>
                <a:latin typeface="Courier New"/>
              </a:rPr>
              <a:t>N</a:t>
            </a: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  R </a:t>
            </a:r>
            <a:r>
              <a:rPr b="1" lang="en-AU" sz="4000" spc="-1" strike="noStrike">
                <a:solidFill>
                  <a:srgbClr val="000000"/>
                </a:solidFill>
                <a:latin typeface="Courier New"/>
              </a:rPr>
              <a:t> A  D  A  A  P  T  V  </a:t>
            </a:r>
            <a:r>
              <a:rPr b="1" i="1" lang="en-AU" sz="4000" spc="-1" strike="noStrike">
                <a:solidFill>
                  <a:srgbClr val="000000"/>
                </a:solidFill>
                <a:latin typeface="Courier New"/>
              </a:rPr>
              <a:t>S  I  F  P  P  S  S  E  </a:t>
            </a:r>
            <a:r>
              <a:rPr b="1" i="1" lang="pt-BR" sz="4000" spc="-1" strike="noStrike">
                <a:solidFill>
                  <a:srgbClr val="000000"/>
                </a:solidFill>
                <a:latin typeface="Courier New"/>
              </a:rPr>
              <a:t>Q  L  T  S  G  G  A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057400" y="13487400"/>
            <a:ext cx="1447920" cy="533520"/>
          </a:xfrm>
          <a:prstGeom prst="rightArrow">
            <a:avLst>
              <a:gd name="adj1" fmla="val 50000"/>
              <a:gd name="adj2" fmla="val 67848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2936320" y="19126080"/>
            <a:ext cx="3504960" cy="533520"/>
          </a:xfrm>
          <a:prstGeom prst="rightArrow">
            <a:avLst>
              <a:gd name="adj1" fmla="val 50000"/>
              <a:gd name="adj2" fmla="val 164238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25450920" y="18364320"/>
            <a:ext cx="1295280" cy="1371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7467480" y="19202400"/>
            <a:ext cx="5257800" cy="533520"/>
          </a:xfrm>
          <a:prstGeom prst="rightArrow">
            <a:avLst>
              <a:gd name="adj1" fmla="val 50000"/>
              <a:gd name="adj2" fmla="val 124692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7449920" y="13411080"/>
            <a:ext cx="5257800" cy="533520"/>
          </a:xfrm>
          <a:prstGeom prst="rightArrow">
            <a:avLst>
              <a:gd name="adj1" fmla="val 50000"/>
              <a:gd name="adj2" fmla="val 124692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7391520" y="8610480"/>
            <a:ext cx="5257800" cy="533520"/>
          </a:xfrm>
          <a:prstGeom prst="rightArrow">
            <a:avLst>
              <a:gd name="adj1" fmla="val 50000"/>
              <a:gd name="adj2" fmla="val 124692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4724280" y="3886200"/>
            <a:ext cx="3429000" cy="609480"/>
          </a:xfrm>
          <a:prstGeom prst="rightArrow">
            <a:avLst>
              <a:gd name="adj1" fmla="val 42806"/>
              <a:gd name="adj2" fmla="val 83245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8516600" y="3962520"/>
            <a:ext cx="6019920" cy="609480"/>
          </a:xfrm>
          <a:prstGeom prst="rightArrow">
            <a:avLst>
              <a:gd name="adj1" fmla="val 50000"/>
              <a:gd name="adj2" fmla="val 111987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8440280" y="8610480"/>
            <a:ext cx="4343400" cy="533520"/>
          </a:xfrm>
          <a:prstGeom prst="rightArrow">
            <a:avLst>
              <a:gd name="adj1" fmla="val 50000"/>
              <a:gd name="adj2" fmla="val 94903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0134720" y="13411080"/>
            <a:ext cx="5257800" cy="533520"/>
          </a:xfrm>
          <a:prstGeom prst="rightArrow">
            <a:avLst>
              <a:gd name="adj1" fmla="val 50000"/>
              <a:gd name="adj2" fmla="val 124692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0287000" y="24460200"/>
            <a:ext cx="4343400" cy="533520"/>
          </a:xfrm>
          <a:prstGeom prst="rightArrow">
            <a:avLst>
              <a:gd name="adj1" fmla="val 50000"/>
              <a:gd name="adj2" fmla="val 94903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rot="16200000">
            <a:off x="19888200" y="21945600"/>
            <a:ext cx="380880" cy="5562720"/>
          </a:xfrm>
          <a:prstGeom prst="can">
            <a:avLst>
              <a:gd name="adj" fmla="val 3000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0210680" y="3886200"/>
            <a:ext cx="3429000" cy="609480"/>
          </a:xfrm>
          <a:prstGeom prst="rightArrow">
            <a:avLst>
              <a:gd name="adj1" fmla="val 42806"/>
              <a:gd name="adj2" fmla="val 83245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981080" y="24460200"/>
            <a:ext cx="1447920" cy="533520"/>
          </a:xfrm>
          <a:prstGeom prst="rightArrow">
            <a:avLst>
              <a:gd name="adj1" fmla="val 50000"/>
              <a:gd name="adj2" fmla="val 67848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914400" y="24307920"/>
            <a:ext cx="1143000" cy="761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2-18T15:26:30Z</dcterms:created>
  <dc:creator>abatchel</dc:creator>
  <dc:description/>
  <dc:language>en-US</dc:language>
  <cp:lastModifiedBy>Daniel Amzel</cp:lastModifiedBy>
  <dcterms:modified xsi:type="dcterms:W3CDTF">2007-05-09T09:55:19Z</dcterms:modified>
  <cp:revision>36</cp:revision>
  <dc:subject/>
  <dc:title>Slide 1</dc:title>
</cp:coreProperties>
</file>